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87"/>
  </p:normalViewPr>
  <p:slideViewPr>
    <p:cSldViewPr snapToGrid="0">
      <p:cViewPr>
        <p:scale>
          <a:sx n="112" d="100"/>
          <a:sy n="112" d="100"/>
        </p:scale>
        <p:origin x="576" y="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B6F32-4DA6-C445-D4F3-F37835ECE4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C1874D-FA47-34BA-D47F-8C7602CCDA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AC662A-6A92-D3BC-7B60-FA705E357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5FDAF-B95D-45B6-ADB1-5D62546DB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E916ED-D732-6FA2-C88D-8D6CA81EB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869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5355B-81E5-81C9-9EE4-A8B52F55F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E5155-7D2F-6932-F077-221521E448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FDE7C1-32E9-6525-A4B3-4EF937655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2E276-2602-85A3-75A9-714A15627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0B5BB-9214-D0A4-4F37-EE2ED87F9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94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9E1D69-29A6-A0F1-4803-21B63BC239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F4B14B-FA6B-68E4-6CC3-243133237D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80B2B5-447C-D455-AEF7-5E420E8F8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18D5F-B669-E4B4-C67A-D61487DED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1B99CC-31B8-4078-A754-350A0E812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607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896F55-E74F-7215-3F29-96917D048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263E51-E08D-D9DA-D07B-D05A319C63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A9BB22-E5B9-5D8C-BD5F-CE09D9E11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89388-C1FF-0DE5-F0EA-7DCCC7165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A1F728-379A-D4D4-86C3-0340E5E7C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100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1FA29-EEC3-AD7D-303A-87660054A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CB7765-4551-9DA8-D9D2-493BB5004E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9F1B1E-7226-8411-3FD0-EDDC3C956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D7E92-CBFE-C1CC-0DDD-AD120FAF0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685600-129D-ADC2-CEE9-60CD7EDCE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204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D26FA-7238-2934-BE24-99FE7FD9E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61F3A-DD9B-D406-F4A8-1C4838101F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C44B28-2E4C-AFC7-5CF2-8D45F33432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8CE26E-85E5-7989-6762-12F79F78D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FD4E9D-3AFF-FCD0-0E4B-EF97DC090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B2E74F-FE8E-45BB-DCDC-082C6BDF6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177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39B16-38CF-0289-623E-33B0A970C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CA2BBA-376F-B8F9-7E8C-C925A7C2FD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88713C-F06C-F1C9-836F-18C822C6D9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C825D1-FCB6-685C-0138-378197316B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684A47-1844-6241-F48E-139E32F69B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7CA03A-24FE-F0BE-B20A-9F60CD93F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5D15D3-BEBE-ACCF-8AA5-252DA28BD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2DAE62-D304-A767-618F-1BA76768D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812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076F43-A2AD-D8F4-01B7-D3741936F0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11B57E-9B16-B0D8-7850-3EB01D70F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D01DFC8-FCEE-2846-EFA7-8622A13BF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986996-2828-3FA8-5396-C50A98376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386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617159-ED10-2C4D-2557-2C9273F26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E2B967-90E6-97F8-4A9F-ABB70F4A5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CA67F5-A457-D37A-DA97-FFA929A6F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523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C05B8-4F7B-C30F-5D88-6949C7F64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CCAF48-A294-3BC2-0F53-81923C94AF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84F26D-10D1-FD7C-8E08-739CEAD11C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1C6D48-9513-980F-1688-09639656D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39C1B8-145E-916F-FB49-87F61A301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11AADF-B016-3DBA-6925-F04CC7625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518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D34BA-D874-968C-3BDC-C450503AF4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E26244-3580-548B-CD73-83BB1986E8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D2C290-E4CA-EFE0-C46D-F59FDB7A1A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8EA4FC-F736-40E8-50E7-CAD1397A7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E4E796-B312-2069-6703-6D2F2AE5E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737104-3925-BAC9-6E56-84825134C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851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632E0C-8EAB-353A-86E0-82E9F23A3A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D58176-04D7-DCDF-4934-467BA25402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9F83C-2A87-957E-2A73-286B5445C6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BED0C-6BD0-D144-B788-A2DD50572E60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021683-37A1-C3D7-F2B0-2E250E3699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6FD948-20F1-E37E-D51B-AF9F48E911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56A4A-100F-7341-9996-216445D574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878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595B1FD-7F45-D06B-AA0F-05F6CB55C3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1181482"/>
              </p:ext>
            </p:extLst>
          </p:nvPr>
        </p:nvGraphicFramePr>
        <p:xfrm>
          <a:off x="2180456" y="188821"/>
          <a:ext cx="7243117" cy="2558082"/>
        </p:xfrm>
        <a:graphic>
          <a:graphicData uri="http://schemas.openxmlformats.org/drawingml/2006/table">
            <a:tbl>
              <a:tblPr/>
              <a:tblGrid>
                <a:gridCol w="919853">
                  <a:extLst>
                    <a:ext uri="{9D8B030D-6E8A-4147-A177-3AD203B41FA5}">
                      <a16:colId xmlns:a16="http://schemas.microsoft.com/office/drawing/2014/main" val="525671214"/>
                    </a:ext>
                  </a:extLst>
                </a:gridCol>
                <a:gridCol w="655661">
                  <a:extLst>
                    <a:ext uri="{9D8B030D-6E8A-4147-A177-3AD203B41FA5}">
                      <a16:colId xmlns:a16="http://schemas.microsoft.com/office/drawing/2014/main" val="1830617220"/>
                    </a:ext>
                  </a:extLst>
                </a:gridCol>
                <a:gridCol w="732796">
                  <a:extLst>
                    <a:ext uri="{9D8B030D-6E8A-4147-A177-3AD203B41FA5}">
                      <a16:colId xmlns:a16="http://schemas.microsoft.com/office/drawing/2014/main" val="901957231"/>
                    </a:ext>
                  </a:extLst>
                </a:gridCol>
                <a:gridCol w="734726">
                  <a:extLst>
                    <a:ext uri="{9D8B030D-6E8A-4147-A177-3AD203B41FA5}">
                      <a16:colId xmlns:a16="http://schemas.microsoft.com/office/drawing/2014/main" val="703148999"/>
                    </a:ext>
                  </a:extLst>
                </a:gridCol>
                <a:gridCol w="701942">
                  <a:extLst>
                    <a:ext uri="{9D8B030D-6E8A-4147-A177-3AD203B41FA5}">
                      <a16:colId xmlns:a16="http://schemas.microsoft.com/office/drawing/2014/main" val="1157192321"/>
                    </a:ext>
                  </a:extLst>
                </a:gridCol>
                <a:gridCol w="701942">
                  <a:extLst>
                    <a:ext uri="{9D8B030D-6E8A-4147-A177-3AD203B41FA5}">
                      <a16:colId xmlns:a16="http://schemas.microsoft.com/office/drawing/2014/main" val="580756866"/>
                    </a:ext>
                  </a:extLst>
                </a:gridCol>
                <a:gridCol w="663374">
                  <a:extLst>
                    <a:ext uri="{9D8B030D-6E8A-4147-A177-3AD203B41FA5}">
                      <a16:colId xmlns:a16="http://schemas.microsoft.com/office/drawing/2014/main" val="2923857874"/>
                    </a:ext>
                  </a:extLst>
                </a:gridCol>
                <a:gridCol w="665301">
                  <a:extLst>
                    <a:ext uri="{9D8B030D-6E8A-4147-A177-3AD203B41FA5}">
                      <a16:colId xmlns:a16="http://schemas.microsoft.com/office/drawing/2014/main" val="3774255964"/>
                    </a:ext>
                  </a:extLst>
                </a:gridCol>
                <a:gridCol w="732796">
                  <a:extLst>
                    <a:ext uri="{9D8B030D-6E8A-4147-A177-3AD203B41FA5}">
                      <a16:colId xmlns:a16="http://schemas.microsoft.com/office/drawing/2014/main" val="3703011749"/>
                    </a:ext>
                  </a:extLst>
                </a:gridCol>
                <a:gridCol w="734726">
                  <a:extLst>
                    <a:ext uri="{9D8B030D-6E8A-4147-A177-3AD203B41FA5}">
                      <a16:colId xmlns:a16="http://schemas.microsoft.com/office/drawing/2014/main" val="1105639146"/>
                    </a:ext>
                  </a:extLst>
                </a:gridCol>
              </a:tblGrid>
              <a:tr h="25380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 Strain Regional Correlation DMD CM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stolic Strain Rate Correlation DMD CM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1662866"/>
                  </a:ext>
                </a:extLst>
              </a:tr>
              <a:tr h="1772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1975851"/>
                  </a:ext>
                </a:extLst>
              </a:tr>
              <a:tr h="17725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mferenti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1360877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451012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4615953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7599145"/>
                  </a:ext>
                </a:extLst>
              </a:tr>
              <a:tr h="17725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3160588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2163212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146587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6043887"/>
                  </a:ext>
                </a:extLst>
              </a:tr>
              <a:tr h="17725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Area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7696196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0952016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3556459"/>
                  </a:ext>
                </a:extLst>
              </a:tr>
              <a:tr h="177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5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8793" marR="8793" marT="8793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3322136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27286D0-9747-0D0E-E3A7-A9790563B3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2118630"/>
              </p:ext>
            </p:extLst>
          </p:nvPr>
        </p:nvGraphicFramePr>
        <p:xfrm>
          <a:off x="2180456" y="2746903"/>
          <a:ext cx="7243118" cy="1929815"/>
        </p:xfrm>
        <a:graphic>
          <a:graphicData uri="http://schemas.openxmlformats.org/drawingml/2006/table">
            <a:tbl>
              <a:tblPr/>
              <a:tblGrid>
                <a:gridCol w="854675">
                  <a:extLst>
                    <a:ext uri="{9D8B030D-6E8A-4147-A177-3AD203B41FA5}">
                      <a16:colId xmlns:a16="http://schemas.microsoft.com/office/drawing/2014/main" val="350637933"/>
                    </a:ext>
                  </a:extLst>
                </a:gridCol>
                <a:gridCol w="921857">
                  <a:extLst>
                    <a:ext uri="{9D8B030D-6E8A-4147-A177-3AD203B41FA5}">
                      <a16:colId xmlns:a16="http://schemas.microsoft.com/office/drawing/2014/main" val="2025647285"/>
                    </a:ext>
                  </a:extLst>
                </a:gridCol>
                <a:gridCol w="826295">
                  <a:extLst>
                    <a:ext uri="{9D8B030D-6E8A-4147-A177-3AD203B41FA5}">
                      <a16:colId xmlns:a16="http://schemas.microsoft.com/office/drawing/2014/main" val="3683058495"/>
                    </a:ext>
                  </a:extLst>
                </a:gridCol>
                <a:gridCol w="828469">
                  <a:extLst>
                    <a:ext uri="{9D8B030D-6E8A-4147-A177-3AD203B41FA5}">
                      <a16:colId xmlns:a16="http://schemas.microsoft.com/office/drawing/2014/main" val="4066249982"/>
                    </a:ext>
                  </a:extLst>
                </a:gridCol>
                <a:gridCol w="791502">
                  <a:extLst>
                    <a:ext uri="{9D8B030D-6E8A-4147-A177-3AD203B41FA5}">
                      <a16:colId xmlns:a16="http://schemas.microsoft.com/office/drawing/2014/main" val="1050096060"/>
                    </a:ext>
                  </a:extLst>
                </a:gridCol>
                <a:gridCol w="791502">
                  <a:extLst>
                    <a:ext uri="{9D8B030D-6E8A-4147-A177-3AD203B41FA5}">
                      <a16:colId xmlns:a16="http://schemas.microsoft.com/office/drawing/2014/main" val="1976829690"/>
                    </a:ext>
                  </a:extLst>
                </a:gridCol>
                <a:gridCol w="748013">
                  <a:extLst>
                    <a:ext uri="{9D8B030D-6E8A-4147-A177-3AD203B41FA5}">
                      <a16:colId xmlns:a16="http://schemas.microsoft.com/office/drawing/2014/main" val="2711263194"/>
                    </a:ext>
                  </a:extLst>
                </a:gridCol>
                <a:gridCol w="750186">
                  <a:extLst>
                    <a:ext uri="{9D8B030D-6E8A-4147-A177-3AD203B41FA5}">
                      <a16:colId xmlns:a16="http://schemas.microsoft.com/office/drawing/2014/main" val="1162831354"/>
                    </a:ext>
                  </a:extLst>
                </a:gridCol>
                <a:gridCol w="730619">
                  <a:extLst>
                    <a:ext uri="{9D8B030D-6E8A-4147-A177-3AD203B41FA5}">
                      <a16:colId xmlns:a16="http://schemas.microsoft.com/office/drawing/2014/main" val="1338360321"/>
                    </a:ext>
                  </a:extLst>
                </a:gridCol>
              </a:tblGrid>
              <a:tr h="15028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 Strain Regional Correlation DMD C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1095992"/>
                  </a:ext>
                </a:extLst>
              </a:tr>
              <a:tr h="261010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9805631"/>
                  </a:ext>
                </a:extLst>
              </a:tr>
              <a:tr h="261010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itudin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4994761"/>
                  </a:ext>
                </a:extLst>
              </a:tr>
              <a:tr h="1502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3325641"/>
                  </a:ext>
                </a:extLst>
              </a:tr>
              <a:tr h="1502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849457"/>
                  </a:ext>
                </a:extLst>
              </a:tr>
              <a:tr h="1502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5196106"/>
                  </a:ext>
                </a:extLst>
              </a:tr>
              <a:tr h="1574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3374706"/>
                  </a:ext>
                </a:extLst>
              </a:tr>
              <a:tr h="26101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0501380"/>
                  </a:ext>
                </a:extLst>
              </a:tr>
              <a:tr h="1574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7627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E6E445AC-A4C8-AF0B-1716-29DA0BC8BF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1943952"/>
              </p:ext>
            </p:extLst>
          </p:nvPr>
        </p:nvGraphicFramePr>
        <p:xfrm>
          <a:off x="2180457" y="4676718"/>
          <a:ext cx="7243116" cy="1929815"/>
        </p:xfrm>
        <a:graphic>
          <a:graphicData uri="http://schemas.openxmlformats.org/drawingml/2006/table">
            <a:tbl>
              <a:tblPr/>
              <a:tblGrid>
                <a:gridCol w="1037216">
                  <a:extLst>
                    <a:ext uri="{9D8B030D-6E8A-4147-A177-3AD203B41FA5}">
                      <a16:colId xmlns:a16="http://schemas.microsoft.com/office/drawing/2014/main" val="2391645678"/>
                    </a:ext>
                  </a:extLst>
                </a:gridCol>
                <a:gridCol w="739316">
                  <a:extLst>
                    <a:ext uri="{9D8B030D-6E8A-4147-A177-3AD203B41FA5}">
                      <a16:colId xmlns:a16="http://schemas.microsoft.com/office/drawing/2014/main" val="3507260321"/>
                    </a:ext>
                  </a:extLst>
                </a:gridCol>
                <a:gridCol w="826294">
                  <a:extLst>
                    <a:ext uri="{9D8B030D-6E8A-4147-A177-3AD203B41FA5}">
                      <a16:colId xmlns:a16="http://schemas.microsoft.com/office/drawing/2014/main" val="452976129"/>
                    </a:ext>
                  </a:extLst>
                </a:gridCol>
                <a:gridCol w="828468">
                  <a:extLst>
                    <a:ext uri="{9D8B030D-6E8A-4147-A177-3AD203B41FA5}">
                      <a16:colId xmlns:a16="http://schemas.microsoft.com/office/drawing/2014/main" val="29828834"/>
                    </a:ext>
                  </a:extLst>
                </a:gridCol>
                <a:gridCol w="791502">
                  <a:extLst>
                    <a:ext uri="{9D8B030D-6E8A-4147-A177-3AD203B41FA5}">
                      <a16:colId xmlns:a16="http://schemas.microsoft.com/office/drawing/2014/main" val="4150407855"/>
                    </a:ext>
                  </a:extLst>
                </a:gridCol>
                <a:gridCol w="791502">
                  <a:extLst>
                    <a:ext uri="{9D8B030D-6E8A-4147-A177-3AD203B41FA5}">
                      <a16:colId xmlns:a16="http://schemas.microsoft.com/office/drawing/2014/main" val="901166950"/>
                    </a:ext>
                  </a:extLst>
                </a:gridCol>
                <a:gridCol w="748013">
                  <a:extLst>
                    <a:ext uri="{9D8B030D-6E8A-4147-A177-3AD203B41FA5}">
                      <a16:colId xmlns:a16="http://schemas.microsoft.com/office/drawing/2014/main" val="2101263100"/>
                    </a:ext>
                  </a:extLst>
                </a:gridCol>
                <a:gridCol w="750187">
                  <a:extLst>
                    <a:ext uri="{9D8B030D-6E8A-4147-A177-3AD203B41FA5}">
                      <a16:colId xmlns:a16="http://schemas.microsoft.com/office/drawing/2014/main" val="64086800"/>
                    </a:ext>
                  </a:extLst>
                </a:gridCol>
                <a:gridCol w="730618">
                  <a:extLst>
                    <a:ext uri="{9D8B030D-6E8A-4147-A177-3AD203B41FA5}">
                      <a16:colId xmlns:a16="http://schemas.microsoft.com/office/drawing/2014/main" val="4134859825"/>
                    </a:ext>
                  </a:extLst>
                </a:gridCol>
              </a:tblGrid>
              <a:tr h="1989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stolic Strain Rate Regional Correlation DMD C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0398656"/>
                  </a:ext>
                </a:extLst>
              </a:tr>
              <a:tr h="1989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6492052"/>
                  </a:ext>
                </a:extLst>
              </a:tr>
              <a:tr h="218845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itudina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405103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8696714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609658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S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1939584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7026809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FW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0474352"/>
                  </a:ext>
                </a:extLst>
              </a:tr>
              <a:tr h="218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43266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9389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299</Words>
  <Application>Microsoft Macintosh PowerPoint</Application>
  <PresentationFormat>Widescreen</PresentationFormat>
  <Paragraphs>26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r Earl</dc:creator>
  <cp:lastModifiedBy>Conner Earl</cp:lastModifiedBy>
  <cp:revision>2</cp:revision>
  <dcterms:created xsi:type="dcterms:W3CDTF">2022-10-31T17:39:32Z</dcterms:created>
  <dcterms:modified xsi:type="dcterms:W3CDTF">2022-10-31T18:41:49Z</dcterms:modified>
</cp:coreProperties>
</file>